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8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笠井 高士" userId="b739b569911c36d1" providerId="LiveId" clId="{BBFC975D-9B13-43B1-BA95-8C97FB216E64}"/>
    <pc:docChg chg="modSld">
      <pc:chgData name="笠井 高士" userId="b739b569911c36d1" providerId="LiveId" clId="{BBFC975D-9B13-43B1-BA95-8C97FB216E64}" dt="2022-12-30T04:09:14.364" v="4" actId="207"/>
      <pc:docMkLst>
        <pc:docMk/>
      </pc:docMkLst>
      <pc:sldChg chg="modSp mod">
        <pc:chgData name="笠井 高士" userId="b739b569911c36d1" providerId="LiveId" clId="{BBFC975D-9B13-43B1-BA95-8C97FB216E64}" dt="2022-12-30T00:51:06.182" v="1" actId="207"/>
        <pc:sldMkLst>
          <pc:docMk/>
          <pc:sldMk cId="2134176668" sldId="263"/>
        </pc:sldMkLst>
        <pc:spChg chg="mod">
          <ac:chgData name="笠井 高士" userId="b739b569911c36d1" providerId="LiveId" clId="{BBFC975D-9B13-43B1-BA95-8C97FB216E64}" dt="2022-12-30T00:50:57.433" v="0" actId="207"/>
          <ac:spMkLst>
            <pc:docMk/>
            <pc:sldMk cId="2134176668" sldId="263"/>
            <ac:spMk id="4" creationId="{F1D474B2-8746-4B43-9085-4DA4743C89EA}"/>
          </ac:spMkLst>
        </pc:spChg>
        <pc:spChg chg="mod">
          <ac:chgData name="笠井 高士" userId="b739b569911c36d1" providerId="LiveId" clId="{BBFC975D-9B13-43B1-BA95-8C97FB216E64}" dt="2022-12-30T00:51:06.182" v="1" actId="207"/>
          <ac:spMkLst>
            <pc:docMk/>
            <pc:sldMk cId="2134176668" sldId="263"/>
            <ac:spMk id="5" creationId="{F98E99C1-AB22-4DB7-9DCE-AC0F396D1B96}"/>
          </ac:spMkLst>
        </pc:spChg>
      </pc:sldChg>
      <pc:sldChg chg="modSp mod">
        <pc:chgData name="笠井 高士" userId="b739b569911c36d1" providerId="LiveId" clId="{BBFC975D-9B13-43B1-BA95-8C97FB216E64}" dt="2022-12-30T04:09:14.364" v="4" actId="207"/>
        <pc:sldMkLst>
          <pc:docMk/>
          <pc:sldMk cId="1641490721" sldId="264"/>
        </pc:sldMkLst>
        <pc:spChg chg="mod">
          <ac:chgData name="笠井 高士" userId="b739b569911c36d1" providerId="LiveId" clId="{BBFC975D-9B13-43B1-BA95-8C97FB216E64}" dt="2022-12-30T04:09:02.636" v="2" actId="207"/>
          <ac:spMkLst>
            <pc:docMk/>
            <pc:sldMk cId="1641490721" sldId="264"/>
            <ac:spMk id="4" creationId="{F1D474B2-8746-4B43-9085-4DA4743C89EA}"/>
          </ac:spMkLst>
        </pc:spChg>
        <pc:spChg chg="mod">
          <ac:chgData name="笠井 高士" userId="b739b569911c36d1" providerId="LiveId" clId="{BBFC975D-9B13-43B1-BA95-8C97FB216E64}" dt="2022-12-30T04:09:10.509" v="3" actId="207"/>
          <ac:spMkLst>
            <pc:docMk/>
            <pc:sldMk cId="1641490721" sldId="264"/>
            <ac:spMk id="5" creationId="{F98E99C1-AB22-4DB7-9DCE-AC0F396D1B96}"/>
          </ac:spMkLst>
        </pc:spChg>
        <pc:spChg chg="mod">
          <ac:chgData name="笠井 高士" userId="b739b569911c36d1" providerId="LiveId" clId="{BBFC975D-9B13-43B1-BA95-8C97FB216E64}" dt="2022-12-30T04:09:14.364" v="4" actId="207"/>
          <ac:spMkLst>
            <pc:docMk/>
            <pc:sldMk cId="1641490721" sldId="264"/>
            <ac:spMk id="12" creationId="{8B8F1A30-F3A4-3BF7-191D-CA0FD7933684}"/>
          </ac:spMkLst>
        </pc:spChg>
      </pc:sldChg>
    </pc:docChg>
  </pc:docChgLst>
  <pc:docChgLst>
    <pc:chgData name="笠井 高士" userId="b739b569911c36d1" providerId="LiveId" clId="{2BC72172-4C4B-4F4A-9A7C-9C8728C64031}"/>
    <pc:docChg chg="undo custSel modSld">
      <pc:chgData name="笠井 高士" userId="b739b569911c36d1" providerId="LiveId" clId="{2BC72172-4C4B-4F4A-9A7C-9C8728C64031}" dt="2023-01-21T06:51:11.337" v="310" actId="1076"/>
      <pc:docMkLst>
        <pc:docMk/>
      </pc:docMkLst>
      <pc:sldChg chg="addSp modSp mod">
        <pc:chgData name="笠井 高士" userId="b739b569911c36d1" providerId="LiveId" clId="{2BC72172-4C4B-4F4A-9A7C-9C8728C64031}" dt="2023-01-21T06:51:11.337" v="310" actId="1076"/>
        <pc:sldMkLst>
          <pc:docMk/>
          <pc:sldMk cId="1641490721" sldId="264"/>
        </pc:sldMkLst>
        <pc:spChg chg="mod">
          <ac:chgData name="笠井 高士" userId="b739b569911c36d1" providerId="LiveId" clId="{2BC72172-4C4B-4F4A-9A7C-9C8728C64031}" dt="2023-01-21T01:41:42.122" v="295" actId="1076"/>
          <ac:spMkLst>
            <pc:docMk/>
            <pc:sldMk cId="1641490721" sldId="264"/>
            <ac:spMk id="5" creationId="{F98E99C1-AB22-4DB7-9DCE-AC0F396D1B96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7" creationId="{F20E57A0-67A4-3686-840E-F60302F2400F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8" creationId="{3AA9B300-F6D4-1D0B-24BD-42942B528058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9" creationId="{BF1C3297-34DB-8DB7-62CE-2DA58BC60026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1" creationId="{F0ADF4F3-F362-3C16-27B4-2A1CB60AF4DE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2" creationId="{8B8F1A30-F3A4-3BF7-191D-CA0FD7933684}"/>
          </ac:spMkLst>
        </pc:spChg>
        <pc:spChg chg="add 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4" creationId="{B75016E2-91EB-6DF9-CF96-E94600554DDF}"/>
          </ac:spMkLst>
        </pc:spChg>
        <pc:graphicFrameChg chg="mod">
          <ac:chgData name="笠井 高士" userId="b739b569911c36d1" providerId="LiveId" clId="{2BC72172-4C4B-4F4A-9A7C-9C8728C64031}" dt="2023-01-21T06:51:10.033" v="309" actId="1076"/>
          <ac:graphicFrameMkLst>
            <pc:docMk/>
            <pc:sldMk cId="1641490721" sldId="264"/>
            <ac:graphicFrameMk id="2" creationId="{F243205E-C48C-488E-1A26-EFE92C3C71D3}"/>
          </ac:graphicFrameMkLst>
        </pc:graphicFrameChg>
        <pc:graphicFrameChg chg="mod">
          <ac:chgData name="笠井 高士" userId="b739b569911c36d1" providerId="LiveId" clId="{2BC72172-4C4B-4F4A-9A7C-9C8728C64031}" dt="2023-01-21T06:50:08.816" v="297" actId="1076"/>
          <ac:graphicFrameMkLst>
            <pc:docMk/>
            <pc:sldMk cId="1641490721" sldId="264"/>
            <ac:graphicFrameMk id="3" creationId="{238C4FEB-A0A9-5CEF-FD83-FB8087A4B7A8}"/>
          </ac:graphicFrameMkLst>
        </pc:graphicFrameChg>
        <pc:graphicFrameChg chg="mod">
          <ac:chgData name="笠井 高士" userId="b739b569911c36d1" providerId="LiveId" clId="{2BC72172-4C4B-4F4A-9A7C-9C8728C64031}" dt="2023-01-21T06:50:19.641" v="299" actId="14100"/>
          <ac:graphicFrameMkLst>
            <pc:docMk/>
            <pc:sldMk cId="1641490721" sldId="264"/>
            <ac:graphicFrameMk id="6" creationId="{9F089E6E-299B-D390-6B0E-484D2EA2A026}"/>
          </ac:graphicFrameMkLst>
        </pc:graphicFrameChg>
        <pc:graphicFrameChg chg="mod">
          <ac:chgData name="笠井 高士" userId="b739b569911c36d1" providerId="LiveId" clId="{2BC72172-4C4B-4F4A-9A7C-9C8728C64031}" dt="2023-01-21T06:51:11.337" v="310" actId="1076"/>
          <ac:graphicFrameMkLst>
            <pc:docMk/>
            <pc:sldMk cId="1641490721" sldId="264"/>
            <ac:graphicFrameMk id="10" creationId="{99D1927E-8240-54E0-14D1-4325850638F8}"/>
          </ac:graphicFrameMkLst>
        </pc:graphicFrameChg>
        <pc:graphicFrameChg chg="add mod">
          <ac:chgData name="笠井 高士" userId="b739b569911c36d1" providerId="LiveId" clId="{2BC72172-4C4B-4F4A-9A7C-9C8728C64031}" dt="2023-01-21T06:50:30.804" v="301" actId="1076"/>
          <ac:graphicFrameMkLst>
            <pc:docMk/>
            <pc:sldMk cId="1641490721" sldId="264"/>
            <ac:graphicFrameMk id="13" creationId="{EA5AB24F-0F96-3B27-4167-38BB5B552436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9F9342-480D-4AB6-A8E9-6BA7628F79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5362AA7-77A6-4994-B024-A2E765F2AA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FE86D4-82BE-4526-B656-E8D7A7F30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CCCE04-7CCF-404A-A759-C10802EDA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E1A051-6060-4722-893F-03367777C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94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178190-71C3-48C5-99E3-9A33B393F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EFF568-9CE5-482A-8424-1BB14A69E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8C4672-3C15-4D90-857E-8DCB1CD94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F26533-DCC4-4DE3-A767-4E443094B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FFD0F3-51DD-44FE-BD6B-700911906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734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19DA1A3-9FAA-4F89-A0F3-F7E58C10AD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47626A0-44F9-4A58-AC7C-6BEE35C3D8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8F63BA-3542-409C-9B98-3DEC45407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E8AE5F-071D-4E30-9150-7B3DB7463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E07C92-8FEC-4D1E-BFB7-C686D1AE6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47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2E5299-4A95-4CF6-83AE-7A97D8D057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1F919D-86A6-42F5-A205-84046E9003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9DE45F-9944-4819-85AB-F0360F980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B32846-680D-4909-A5B1-7EADD2CF5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1B8C48-4F99-4EC4-8906-56341F2F9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70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11F587-4158-4281-B5A7-059B68416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8CD6E4-631D-4554-AE79-757EF354B6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497F7D-D853-45CF-A79D-E67E018F3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BEE5CA-3B5D-4C7C-9CF9-213F11424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7F87B4-C222-4717-B6C2-DC10B65CD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572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CAD35D-C11A-437F-96D0-48A7674A0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47FD68-B723-4A12-94C6-E6D6B8A64B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3386AC-7378-49FB-96AA-FEADEE900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1014B0-413A-4E28-A923-205BCB83D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FDEF19-5497-4554-BA05-515FB6679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266CA1-B4CA-4D30-AEF8-41457765B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633FCF-1A8D-4BFA-84FB-F4AD8F8D6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08CFA5F-5E66-499C-8A1B-77827573E2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7D78E87-F3A4-47C3-8EA3-037431C446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8C3CE1F-856C-49BA-BB46-C3C2612589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EBF08D-3156-47B0-8545-0CE547DF5B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FEBD36C-73A6-4D58-BAF5-548206F4A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4FE0F4F-1802-45F9-BB94-AA5CBE3BB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18342BC-EE7B-4346-8813-4188F115B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509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B4075D-128D-415B-BF3A-88BAA9BD3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AC8B7F-0DF3-4C45-B47B-DDC140318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792D249-4F38-4E90-9EB7-A4096C44F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6982EA-BAD1-4147-9C46-8F7C29BF8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601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6C7F17-ECAB-4611-8FDA-8A26B8BE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1F7FB2A-0B70-4691-A851-0E5D205F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2051C2-4E05-4667-8369-C6AE71609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900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4F6D01-2353-4AE2-AF66-7344B40830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819385-9AF4-419F-BE0F-6E9620CD68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E3AB37-CE72-460C-9C2E-D3DAFC680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46568B-8AD4-49CB-B057-67C091ECC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F64079F-24FB-4A26-8D1E-7AB4BA8AA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B311E3-ED29-43ED-928D-BDA26161E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033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3A1443-2BAB-4B03-B0A6-CD5A5100A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6E744CD-0FF8-48C4-AB2D-B264A48EE2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9CC2F75-00AC-4946-A534-D698B6FAA3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2F6DDF-5C2C-4347-B294-11A42971C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25D9C3-7FC0-440C-B8C8-1CD14B09D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C2E728E-5FD7-4D5D-9C8A-92138193E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464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83FEC5D-9F32-4C48-97C5-0D8D565E2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6C7C8E-E50C-40DD-96BE-D29EA95B0C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E14744-9BBF-4779-A770-C623501F9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3F4579-CB4E-47F4-BEC7-E2206FAA6A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C86143-05AF-4DE3-B1CE-E1E3B864AC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712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1D474B2-8746-4B43-9085-4DA4743C89EA}"/>
              </a:ext>
            </a:extLst>
          </p:cNvPr>
          <p:cNvSpPr txBox="1"/>
          <p:nvPr/>
        </p:nvSpPr>
        <p:spPr>
          <a:xfrm>
            <a:off x="11872" y="-25228"/>
            <a:ext cx="79175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S2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800" b="1" kern="1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Serum LRG levels and clinical data in the enrolled participants.</a:t>
            </a:r>
          </a:p>
          <a:p>
            <a:endParaRPr kumimoji="1" lang="ja-JP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8E99C1-AB22-4DB7-9DCE-AC0F396D1B96}"/>
              </a:ext>
            </a:extLst>
          </p:cNvPr>
          <p:cNvSpPr txBox="1"/>
          <p:nvPr/>
        </p:nvSpPr>
        <p:spPr>
          <a:xfrm>
            <a:off x="130468" y="153012"/>
            <a:ext cx="12084810" cy="1318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indent="-342900">
              <a:lnSpc>
                <a:spcPct val="200000"/>
              </a:lnSpc>
              <a:buAutoNum type="alphaUcParenBoth"/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DS-UPDRS part II scores. (B) MDS-UPDRS part II scores. (C) MDS-UPDRS part III scores. </a:t>
            </a:r>
          </a:p>
          <a:p>
            <a:pPr marL="342900" indent="-342900">
              <a:lnSpc>
                <a:spcPct val="200000"/>
              </a:lnSpc>
              <a:buAutoNum type="alphaUcParenBoth"/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D) H/M ratio in the early phase on MIBG myocardial images. (E) SBR on DAT imaging.</a:t>
            </a:r>
          </a:p>
          <a:p>
            <a:pPr>
              <a:lnSpc>
                <a:spcPct val="200000"/>
              </a:lnSpc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re were no statistically significant correlations between these parameters and serum LRG levels.</a:t>
            </a: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F243205E-C48C-488E-1A26-EFE92C3C71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1766233"/>
              </p:ext>
            </p:extLst>
          </p:nvPr>
        </p:nvGraphicFramePr>
        <p:xfrm>
          <a:off x="7284083" y="2749028"/>
          <a:ext cx="2653511" cy="19578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942406" imgH="2908964" progId="Prism6.Document">
                  <p:embed/>
                </p:oleObj>
              </mc:Choice>
              <mc:Fallback>
                <p:oleObj name="Prism 6" r:id="rId2" imgW="3942406" imgH="2908964" progId="Prism6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F243205E-C48C-488E-1A26-EFE92C3C71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84083" y="2749028"/>
                        <a:ext cx="2653511" cy="19578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238C4FEB-A0A9-5CEF-FD83-FB8087A4B7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5357700"/>
              </p:ext>
            </p:extLst>
          </p:nvPr>
        </p:nvGraphicFramePr>
        <p:xfrm>
          <a:off x="-41646" y="2749028"/>
          <a:ext cx="2682796" cy="1979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942406" imgH="2908964" progId="Prism6.Document">
                  <p:embed/>
                </p:oleObj>
              </mc:Choice>
              <mc:Fallback>
                <p:oleObj name="Prism 6" r:id="rId4" imgW="3942406" imgH="2908964" progId="Prism6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238C4FEB-A0A9-5CEF-FD83-FB8087A4B7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41646" y="2749028"/>
                        <a:ext cx="2682796" cy="1979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9F089E6E-299B-D390-6B0E-484D2EA2A0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5030782"/>
              </p:ext>
            </p:extLst>
          </p:nvPr>
        </p:nvGraphicFramePr>
        <p:xfrm>
          <a:off x="2474202" y="2749028"/>
          <a:ext cx="2687967" cy="1983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942406" imgH="2908964" progId="Prism6.Document">
                  <p:embed/>
                </p:oleObj>
              </mc:Choice>
              <mc:Fallback>
                <p:oleObj name="Prism 6" r:id="rId6" imgW="3942406" imgH="2908964" progId="Prism6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9F089E6E-299B-D390-6B0E-484D2EA2A0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74202" y="2749028"/>
                        <a:ext cx="2687967" cy="1983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20E57A0-67A4-3686-840E-F60302F2400F}"/>
              </a:ext>
            </a:extLst>
          </p:cNvPr>
          <p:cNvSpPr txBox="1"/>
          <p:nvPr/>
        </p:nvSpPr>
        <p:spPr>
          <a:xfrm>
            <a:off x="3398" y="2203498"/>
            <a:ext cx="2541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AA9B300-F6D4-1D0B-24BD-42942B528058}"/>
              </a:ext>
            </a:extLst>
          </p:cNvPr>
          <p:cNvSpPr txBox="1"/>
          <p:nvPr/>
        </p:nvSpPr>
        <p:spPr>
          <a:xfrm>
            <a:off x="2431408" y="2181727"/>
            <a:ext cx="132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F1C3297-34DB-8DB7-62CE-2DA58BC60026}"/>
              </a:ext>
            </a:extLst>
          </p:cNvPr>
          <p:cNvSpPr txBox="1"/>
          <p:nvPr/>
        </p:nvSpPr>
        <p:spPr>
          <a:xfrm>
            <a:off x="4905064" y="2123987"/>
            <a:ext cx="313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99D1927E-8240-54E0-14D1-4325850638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8549065"/>
              </p:ext>
            </p:extLst>
          </p:nvPr>
        </p:nvGraphicFramePr>
        <p:xfrm>
          <a:off x="9581948" y="2749028"/>
          <a:ext cx="2633330" cy="19429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3942406" imgH="2908964" progId="Prism6.Document">
                  <p:embed/>
                </p:oleObj>
              </mc:Choice>
              <mc:Fallback>
                <p:oleObj name="Prism 6" r:id="rId8" imgW="3942406" imgH="2908964" progId="Prism6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99D1927E-8240-54E0-14D1-4325850638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581948" y="2749028"/>
                        <a:ext cx="2633330" cy="19429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0ADF4F3-F362-3C16-27B4-2A1CB60AF4DE}"/>
              </a:ext>
            </a:extLst>
          </p:cNvPr>
          <p:cNvSpPr txBox="1"/>
          <p:nvPr/>
        </p:nvSpPr>
        <p:spPr>
          <a:xfrm>
            <a:off x="7372214" y="2150833"/>
            <a:ext cx="313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8F1A30-F3A4-3BF7-191D-CA0FD7933684}"/>
              </a:ext>
            </a:extLst>
          </p:cNvPr>
          <p:cNvSpPr txBox="1"/>
          <p:nvPr/>
        </p:nvSpPr>
        <p:spPr>
          <a:xfrm>
            <a:off x="360218" y="5016677"/>
            <a:ext cx="110874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DAT,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opamine transporter single photon emission computed tomography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/M, heart/mediastinum; LRG, </a:t>
            </a:r>
            <a:r>
              <a:rPr lang="en-US" altLang="ja-JP" sz="1400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</a:t>
            </a:r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ucine-rich α2 glycoprotein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MIBG, myocardial imaging with </a:t>
            </a:r>
            <a:r>
              <a:rPr lang="en-US" altLang="ja-JP" sz="1400" kern="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23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-metaiodobenzylguanidine;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DS, Movement Disorder Society; UPDRS, Unified Parkinson’s Disease Rating Scale; SBR, specific binding ratio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EA5AB24F-0F96-3B27-4167-38BB5B5524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4079471"/>
              </p:ext>
            </p:extLst>
          </p:nvPr>
        </p:nvGraphicFramePr>
        <p:xfrm>
          <a:off x="4905064" y="2745213"/>
          <a:ext cx="2687968" cy="1983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942406" imgH="2908964" progId="Prism6.Document">
                  <p:embed/>
                </p:oleObj>
              </mc:Choice>
              <mc:Fallback>
                <p:oleObj name="Prism 6" r:id="rId10" imgW="3942406" imgH="2908964" progId="Prism6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EA5AB24F-0F96-3B27-4167-38BB5B5524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905064" y="2745213"/>
                        <a:ext cx="2687968" cy="1983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75016E2-91EB-6DF9-CF96-E94600554DDF}"/>
              </a:ext>
            </a:extLst>
          </p:cNvPr>
          <p:cNvSpPr txBox="1"/>
          <p:nvPr/>
        </p:nvSpPr>
        <p:spPr>
          <a:xfrm>
            <a:off x="9780705" y="2149409"/>
            <a:ext cx="313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1490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16</TotalTime>
  <Words>131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卓摩 大道</dc:creator>
  <cp:lastModifiedBy>chn off28</cp:lastModifiedBy>
  <cp:revision>28</cp:revision>
  <dcterms:created xsi:type="dcterms:W3CDTF">2021-06-23T16:38:15Z</dcterms:created>
  <dcterms:modified xsi:type="dcterms:W3CDTF">2023-02-14T19:52:05Z</dcterms:modified>
</cp:coreProperties>
</file>